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60" d="100"/>
          <a:sy n="60" d="100"/>
        </p:scale>
        <p:origin x="-2634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br46295\Desktop\Articulo%20gametocytes_2015\GAM_Cinetica_N8420-2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br46295\Desktop\Articulo%20gametocytes_2015\GAM_Cinetica_N8420-2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title>
      <c:tx>
        <c:rich>
          <a:bodyPr/>
          <a:lstStyle/>
          <a:p>
            <a:pPr>
              <a:defRPr/>
            </a:pPr>
            <a:r>
              <a:rPr lang="es-ES"/>
              <a:t>Young</a:t>
            </a:r>
            <a:r>
              <a:rPr lang="es-ES" baseline="0"/>
              <a:t> stages </a:t>
            </a:r>
            <a:endParaRPr lang="es-ES"/>
          </a:p>
        </c:rich>
      </c:tx>
      <c:layout/>
    </c:title>
    <c:plotArea>
      <c:layout/>
      <c:scatterChart>
        <c:scatterStyle val="smoothMarker"/>
        <c:ser>
          <c:idx val="4"/>
          <c:order val="1"/>
          <c:tx>
            <c:strRef>
              <c:f>'Grafica cinetica'!$B$1</c:f>
              <c:strCache>
                <c:ptCount val="1"/>
                <c:pt idx="0">
                  <c:v>18S rRNA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B$2:$B$32</c:f>
              <c:numCache>
                <c:formatCode>General</c:formatCode>
                <c:ptCount val="3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yVal>
          <c:smooth val="1"/>
        </c:ser>
        <c:ser>
          <c:idx val="8"/>
          <c:order val="2"/>
          <c:tx>
            <c:strRef>
              <c:f>'Grafica cinetica'!$J$1</c:f>
              <c:strCache>
                <c:ptCount val="1"/>
                <c:pt idx="0">
                  <c:v>Pfg14-744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J$2:$J$32</c:f>
              <c:numCache>
                <c:formatCode>General</c:formatCode>
                <c:ptCount val="31"/>
                <c:pt idx="0">
                  <c:v>0</c:v>
                </c:pt>
                <c:pt idx="1">
                  <c:v>-0.3221416473388673</c:v>
                </c:pt>
                <c:pt idx="2">
                  <c:v>-1.4406623840332031</c:v>
                </c:pt>
                <c:pt idx="3">
                  <c:v>-2.3228559494018546</c:v>
                </c:pt>
                <c:pt idx="4">
                  <c:v>-1.816993713378906</c:v>
                </c:pt>
                <c:pt idx="5">
                  <c:v>-2.4811935424804696</c:v>
                </c:pt>
                <c:pt idx="6">
                  <c:v>-2.9220104217529297</c:v>
                </c:pt>
                <c:pt idx="7">
                  <c:v>-3.6649971008300786</c:v>
                </c:pt>
                <c:pt idx="8">
                  <c:v>-2.1216020584106445</c:v>
                </c:pt>
                <c:pt idx="9">
                  <c:v>-3.0068225860595703</c:v>
                </c:pt>
                <c:pt idx="10">
                  <c:v>-2.5434646606445312</c:v>
                </c:pt>
                <c:pt idx="11">
                  <c:v>-1.8690414428710937</c:v>
                </c:pt>
                <c:pt idx="12">
                  <c:v>-2.6590175628662114</c:v>
                </c:pt>
                <c:pt idx="13">
                  <c:v>-2.4543342590332031</c:v>
                </c:pt>
                <c:pt idx="14">
                  <c:v>-3.0065593719482417</c:v>
                </c:pt>
                <c:pt idx="15">
                  <c:v>-2.5971326828002934</c:v>
                </c:pt>
                <c:pt idx="16">
                  <c:v>-2.212610244750977</c:v>
                </c:pt>
                <c:pt idx="17">
                  <c:v>-1.6530723571777344</c:v>
                </c:pt>
                <c:pt idx="18">
                  <c:v>-0.81292438507080078</c:v>
                </c:pt>
                <c:pt idx="19">
                  <c:v>-0.57437992095947277</c:v>
                </c:pt>
                <c:pt idx="20">
                  <c:v>-0.95647811889648449</c:v>
                </c:pt>
                <c:pt idx="21">
                  <c:v>-0.44826698303222667</c:v>
                </c:pt>
                <c:pt idx="22">
                  <c:v>0.6312541961669923</c:v>
                </c:pt>
                <c:pt idx="23">
                  <c:v>0.49434947967529302</c:v>
                </c:pt>
                <c:pt idx="24">
                  <c:v>0.42220211029052002</c:v>
                </c:pt>
                <c:pt idx="25">
                  <c:v>0.75483703613281272</c:v>
                </c:pt>
                <c:pt idx="26">
                  <c:v>0.54234695434570313</c:v>
                </c:pt>
                <c:pt idx="27">
                  <c:v>0.33846282958984397</c:v>
                </c:pt>
                <c:pt idx="28">
                  <c:v>0.14036178588859999</c:v>
                </c:pt>
                <c:pt idx="29">
                  <c:v>0.89980697631835016</c:v>
                </c:pt>
                <c:pt idx="30">
                  <c:v>0.98700523376464844</c:v>
                </c:pt>
              </c:numCache>
            </c:numRef>
          </c:yVal>
          <c:smooth val="1"/>
        </c:ser>
        <c:ser>
          <c:idx val="9"/>
          <c:order val="3"/>
          <c:tx>
            <c:strRef>
              <c:f>'Grafica cinetica'!$K$1</c:f>
              <c:strCache>
                <c:ptCount val="1"/>
                <c:pt idx="0">
                  <c:v>Pfmdv-1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K$2:$K$32</c:f>
              <c:numCache>
                <c:formatCode>General</c:formatCode>
                <c:ptCount val="31"/>
                <c:pt idx="0">
                  <c:v>0</c:v>
                </c:pt>
                <c:pt idx="1">
                  <c:v>-1.3316173553466797</c:v>
                </c:pt>
                <c:pt idx="2">
                  <c:v>-0.7122440338134769</c:v>
                </c:pt>
                <c:pt idx="3">
                  <c:v>-1.8988485336303713</c:v>
                </c:pt>
                <c:pt idx="4">
                  <c:v>-0.62786483764648471</c:v>
                </c:pt>
                <c:pt idx="5">
                  <c:v>-3.7793788909912109</c:v>
                </c:pt>
                <c:pt idx="6">
                  <c:v>-3.7849712371826181</c:v>
                </c:pt>
                <c:pt idx="7">
                  <c:v>-5.8083534240722674</c:v>
                </c:pt>
                <c:pt idx="8">
                  <c:v>-2.0283422470092778</c:v>
                </c:pt>
                <c:pt idx="9">
                  <c:v>-1.9853458404541016</c:v>
                </c:pt>
                <c:pt idx="10">
                  <c:v>-2.5181961059570317</c:v>
                </c:pt>
                <c:pt idx="11">
                  <c:v>-1.9931774139404297</c:v>
                </c:pt>
                <c:pt idx="12">
                  <c:v>-2.9040908813476571</c:v>
                </c:pt>
                <c:pt idx="13">
                  <c:v>-2.660552978515625</c:v>
                </c:pt>
                <c:pt idx="14">
                  <c:v>-3.1834716796875004</c:v>
                </c:pt>
                <c:pt idx="15">
                  <c:v>-3.2536993026733403</c:v>
                </c:pt>
                <c:pt idx="16">
                  <c:v>-5.0804347991943368</c:v>
                </c:pt>
                <c:pt idx="17">
                  <c:v>-4.3517837524414062</c:v>
                </c:pt>
                <c:pt idx="18">
                  <c:v>-4.5383710861206072</c:v>
                </c:pt>
                <c:pt idx="19">
                  <c:v>-4.2894182205200195</c:v>
                </c:pt>
                <c:pt idx="20">
                  <c:v>-4.2957572937011728</c:v>
                </c:pt>
                <c:pt idx="21">
                  <c:v>-4.91829490661621</c:v>
                </c:pt>
                <c:pt idx="22">
                  <c:v>-3.756643295288085</c:v>
                </c:pt>
                <c:pt idx="23">
                  <c:v>-4.030014991760253</c:v>
                </c:pt>
                <c:pt idx="24">
                  <c:v>-4.1736822128295898</c:v>
                </c:pt>
                <c:pt idx="25">
                  <c:v>-3.9114227294921871</c:v>
                </c:pt>
                <c:pt idx="26">
                  <c:v>-3.0563621520996089</c:v>
                </c:pt>
                <c:pt idx="27">
                  <c:v>-3.6146049499511719</c:v>
                </c:pt>
                <c:pt idx="28">
                  <c:v>-3.7728538513183594</c:v>
                </c:pt>
                <c:pt idx="29">
                  <c:v>-4.2043666839599618</c:v>
                </c:pt>
                <c:pt idx="30">
                  <c:v>-3.3608436584472652</c:v>
                </c:pt>
              </c:numCache>
            </c:numRef>
          </c:yVal>
          <c:smooth val="1"/>
        </c:ser>
        <c:ser>
          <c:idx val="11"/>
          <c:order val="4"/>
          <c:tx>
            <c:strRef>
              <c:f>'Grafica cinetica'!$L$1</c:f>
              <c:strCache>
                <c:ptCount val="1"/>
                <c:pt idx="0">
                  <c:v>Pf 27/25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L$2:$L$32</c:f>
              <c:numCache>
                <c:formatCode>General</c:formatCode>
                <c:ptCount val="31"/>
                <c:pt idx="0">
                  <c:v>0</c:v>
                </c:pt>
                <c:pt idx="1">
                  <c:v>0.32274436950683599</c:v>
                </c:pt>
                <c:pt idx="2">
                  <c:v>2.6350193023681636</c:v>
                </c:pt>
                <c:pt idx="3">
                  <c:v>2.2859201431274405</c:v>
                </c:pt>
                <c:pt idx="4">
                  <c:v>-8.2563778686523435</c:v>
                </c:pt>
                <c:pt idx="5">
                  <c:v>-9.1344190216064476</c:v>
                </c:pt>
                <c:pt idx="6">
                  <c:v>-10.613937911987309</c:v>
                </c:pt>
                <c:pt idx="7">
                  <c:v>-11.727780151367188</c:v>
                </c:pt>
                <c:pt idx="8">
                  <c:v>-9.7808170700073234</c:v>
                </c:pt>
                <c:pt idx="9">
                  <c:v>-9.3395241546630867</c:v>
                </c:pt>
                <c:pt idx="10">
                  <c:v>-9.9385922241210967</c:v>
                </c:pt>
                <c:pt idx="11">
                  <c:v>-9.2115647125244138</c:v>
                </c:pt>
                <c:pt idx="12">
                  <c:v>-10.814465179443362</c:v>
                </c:pt>
                <c:pt idx="13">
                  <c:v>-10.754135589599612</c:v>
                </c:pt>
                <c:pt idx="14">
                  <c:v>-11.178120727539062</c:v>
                </c:pt>
                <c:pt idx="15">
                  <c:v>-11.376415367126464</c:v>
                </c:pt>
                <c:pt idx="16">
                  <c:v>-12.231098709106448</c:v>
                </c:pt>
                <c:pt idx="17">
                  <c:v>-12.466453857421877</c:v>
                </c:pt>
                <c:pt idx="18">
                  <c:v>-12.019421882629397</c:v>
                </c:pt>
                <c:pt idx="19">
                  <c:v>-11.5857683944702</c:v>
                </c:pt>
                <c:pt idx="20">
                  <c:v>-11.863481292724611</c:v>
                </c:pt>
                <c:pt idx="21">
                  <c:v>-11.862144546508791</c:v>
                </c:pt>
                <c:pt idx="22">
                  <c:v>-10.840847244262699</c:v>
                </c:pt>
                <c:pt idx="23">
                  <c:v>-11.703681678771972</c:v>
                </c:pt>
                <c:pt idx="24">
                  <c:v>-10.769514045715335</c:v>
                </c:pt>
                <c:pt idx="25">
                  <c:v>-10.703935089111324</c:v>
                </c:pt>
                <c:pt idx="26">
                  <c:v>-10.564605560302734</c:v>
                </c:pt>
                <c:pt idx="27">
                  <c:v>-10.265572967529298</c:v>
                </c:pt>
                <c:pt idx="28">
                  <c:v>-10.316041412353517</c:v>
                </c:pt>
                <c:pt idx="29">
                  <c:v>-10.108908767700193</c:v>
                </c:pt>
                <c:pt idx="30">
                  <c:v>-9.7403051757812502</c:v>
                </c:pt>
              </c:numCache>
            </c:numRef>
          </c:yVal>
          <c:smooth val="1"/>
        </c:ser>
        <c:ser>
          <c:idx val="12"/>
          <c:order val="5"/>
          <c:tx>
            <c:strRef>
              <c:f>'Grafica cinetica'!$M$1</c:f>
              <c:strCache>
                <c:ptCount val="1"/>
                <c:pt idx="0">
                  <c:v>ETRAMP10.3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M$2:$M$32</c:f>
              <c:numCache>
                <c:formatCode>General</c:formatCode>
                <c:ptCount val="31"/>
                <c:pt idx="0">
                  <c:v>0</c:v>
                </c:pt>
                <c:pt idx="1">
                  <c:v>-1.1222556304931643</c:v>
                </c:pt>
                <c:pt idx="2">
                  <c:v>-2.1449806976318375</c:v>
                </c:pt>
                <c:pt idx="3">
                  <c:v>-3.7790798568725603</c:v>
                </c:pt>
                <c:pt idx="4">
                  <c:v>-0.43637786865234329</c:v>
                </c:pt>
                <c:pt idx="5">
                  <c:v>-3.5944190216064484</c:v>
                </c:pt>
                <c:pt idx="6">
                  <c:v>-4.3189379119873044</c:v>
                </c:pt>
                <c:pt idx="7">
                  <c:v>-4.7977801513671885</c:v>
                </c:pt>
                <c:pt idx="8">
                  <c:v>-5.9858170700073252</c:v>
                </c:pt>
                <c:pt idx="9">
                  <c:v>-6.0495241546630867</c:v>
                </c:pt>
                <c:pt idx="10">
                  <c:v>-5.1735922241210943</c:v>
                </c:pt>
                <c:pt idx="11">
                  <c:v>-5.4665647125244163</c:v>
                </c:pt>
                <c:pt idx="12">
                  <c:v>-6.6344651794433602</c:v>
                </c:pt>
                <c:pt idx="13">
                  <c:v>-7.3241355895996083</c:v>
                </c:pt>
                <c:pt idx="14">
                  <c:v>-7.4581207275390655</c:v>
                </c:pt>
                <c:pt idx="15">
                  <c:v>-7.1514153671264626</c:v>
                </c:pt>
                <c:pt idx="16">
                  <c:v>-7.9960987091064455</c:v>
                </c:pt>
                <c:pt idx="17">
                  <c:v>-7.9514538574218756</c:v>
                </c:pt>
                <c:pt idx="18">
                  <c:v>-7.4344218826293949</c:v>
                </c:pt>
                <c:pt idx="19">
                  <c:v>-7.2357683944702185</c:v>
                </c:pt>
                <c:pt idx="20">
                  <c:v>-6.2684812927246103</c:v>
                </c:pt>
                <c:pt idx="21">
                  <c:v>-6.9371445465087884</c:v>
                </c:pt>
                <c:pt idx="22">
                  <c:v>-6.0758472442626976</c:v>
                </c:pt>
                <c:pt idx="23">
                  <c:v>-5.9086816787719725</c:v>
                </c:pt>
                <c:pt idx="24">
                  <c:v>-5.5895140457153323</c:v>
                </c:pt>
                <c:pt idx="25">
                  <c:v>-6.1039350891113315</c:v>
                </c:pt>
                <c:pt idx="26">
                  <c:v>-6.0346055603027366</c:v>
                </c:pt>
                <c:pt idx="27">
                  <c:v>-7.0905729675292957</c:v>
                </c:pt>
                <c:pt idx="28">
                  <c:v>-6.3810414123535191</c:v>
                </c:pt>
                <c:pt idx="29">
                  <c:v>-6.0889087677001967</c:v>
                </c:pt>
                <c:pt idx="30">
                  <c:v>-4.760305175781248</c:v>
                </c:pt>
              </c:numCache>
            </c:numRef>
          </c:yVal>
          <c:smooth val="1"/>
        </c:ser>
        <c:ser>
          <c:idx val="13"/>
          <c:order val="6"/>
          <c:tx>
            <c:strRef>
              <c:f>'Grafica cinetica'!$N$1</c:f>
              <c:strCache>
                <c:ptCount val="1"/>
                <c:pt idx="0">
                  <c:v>pfj14.748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N$2:$N$32</c:f>
              <c:numCache>
                <c:formatCode>General</c:formatCode>
                <c:ptCount val="31"/>
                <c:pt idx="0">
                  <c:v>0</c:v>
                </c:pt>
                <c:pt idx="1">
                  <c:v>0.28547584533691156</c:v>
                </c:pt>
                <c:pt idx="2">
                  <c:v>0.84092014312744112</c:v>
                </c:pt>
                <c:pt idx="3">
                  <c:v>0.86558097839355008</c:v>
                </c:pt>
                <c:pt idx="4">
                  <c:v>0.19106208801269006</c:v>
                </c:pt>
                <c:pt idx="5">
                  <c:v>0.72221984863281008</c:v>
                </c:pt>
                <c:pt idx="6">
                  <c:v>-1.2172556304931668</c:v>
                </c:pt>
                <c:pt idx="7">
                  <c:v>-1.3599806976318403</c:v>
                </c:pt>
                <c:pt idx="8">
                  <c:v>-0.3808170700073249</c:v>
                </c:pt>
                <c:pt idx="9">
                  <c:v>-0.16637786865234719</c:v>
                </c:pt>
                <c:pt idx="10">
                  <c:v>-0.41359222412109625</c:v>
                </c:pt>
                <c:pt idx="11">
                  <c:v>0.91343528747558633</c:v>
                </c:pt>
                <c:pt idx="12">
                  <c:v>-0.60946517944336154</c:v>
                </c:pt>
                <c:pt idx="13">
                  <c:v>-0.6241355895996108</c:v>
                </c:pt>
                <c:pt idx="14">
                  <c:v>-0.77312072753906591</c:v>
                </c:pt>
                <c:pt idx="15">
                  <c:v>-1.0414153671264683</c:v>
                </c:pt>
                <c:pt idx="16">
                  <c:v>-1.3910987091064477</c:v>
                </c:pt>
                <c:pt idx="17">
                  <c:v>-0.47145385742187784</c:v>
                </c:pt>
                <c:pt idx="18">
                  <c:v>-0.23442188262939825</c:v>
                </c:pt>
                <c:pt idx="19">
                  <c:v>7.423160552978203E-2</c:v>
                </c:pt>
                <c:pt idx="20">
                  <c:v>-4.8481292724609666E-2</c:v>
                </c:pt>
                <c:pt idx="21">
                  <c:v>0.39285545349120815</c:v>
                </c:pt>
                <c:pt idx="22">
                  <c:v>0.90415275573729992</c:v>
                </c:pt>
                <c:pt idx="23">
                  <c:v>0.6813183212280266</c:v>
                </c:pt>
                <c:pt idx="24">
                  <c:v>0.13548595428466825</c:v>
                </c:pt>
                <c:pt idx="25">
                  <c:v>0.61106491088867199</c:v>
                </c:pt>
                <c:pt idx="26">
                  <c:v>2.3453944396972655</c:v>
                </c:pt>
                <c:pt idx="27">
                  <c:v>1.6844270324707014</c:v>
                </c:pt>
                <c:pt idx="28">
                  <c:v>-4.1041412353518332E-2</c:v>
                </c:pt>
                <c:pt idx="29">
                  <c:v>0.79609123229980161</c:v>
                </c:pt>
                <c:pt idx="30">
                  <c:v>1.259694824218748</c:v>
                </c:pt>
              </c:numCache>
            </c:numRef>
          </c:yVal>
          <c:smooth val="1"/>
        </c:ser>
        <c:ser>
          <c:idx val="7"/>
          <c:order val="0"/>
          <c:tx>
            <c:strRef>
              <c:f>'Grafica cinetica'!$I$1</c:f>
              <c:strCache>
                <c:ptCount val="1"/>
                <c:pt idx="0">
                  <c:v>Pfs16</c:v>
                </c:pt>
              </c:strCache>
            </c:strRef>
          </c:tx>
          <c:marker>
            <c:symbol val="diamond"/>
            <c:size val="7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I$2:$I$32</c:f>
              <c:numCache>
                <c:formatCode>General</c:formatCode>
                <c:ptCount val="31"/>
                <c:pt idx="0">
                  <c:v>0</c:v>
                </c:pt>
                <c:pt idx="1">
                  <c:v>0.32274436950683599</c:v>
                </c:pt>
                <c:pt idx="2">
                  <c:v>2.6350193023681636</c:v>
                </c:pt>
                <c:pt idx="3">
                  <c:v>2.2859201431274405</c:v>
                </c:pt>
                <c:pt idx="4">
                  <c:v>-15.016377868652341</c:v>
                </c:pt>
                <c:pt idx="5">
                  <c:v>-14.509419021606451</c:v>
                </c:pt>
                <c:pt idx="6">
                  <c:v>-15.793937911987308</c:v>
                </c:pt>
                <c:pt idx="7">
                  <c:v>-15.987780151367186</c:v>
                </c:pt>
                <c:pt idx="8">
                  <c:v>-15.835817070007325</c:v>
                </c:pt>
                <c:pt idx="9">
                  <c:v>-15.509524154663085</c:v>
                </c:pt>
                <c:pt idx="10">
                  <c:v>-15.998592224121095</c:v>
                </c:pt>
                <c:pt idx="11">
                  <c:v>-15.146564712524416</c:v>
                </c:pt>
                <c:pt idx="12">
                  <c:v>-16.344465179443361</c:v>
                </c:pt>
                <c:pt idx="13">
                  <c:v>-16.479135589599604</c:v>
                </c:pt>
                <c:pt idx="14">
                  <c:v>-17.158120727539064</c:v>
                </c:pt>
                <c:pt idx="15">
                  <c:v>-16.901415367126464</c:v>
                </c:pt>
                <c:pt idx="16">
                  <c:v>-17.041098709106446</c:v>
                </c:pt>
                <c:pt idx="17">
                  <c:v>-17.876453857421872</c:v>
                </c:pt>
                <c:pt idx="18">
                  <c:v>-17.649421882629387</c:v>
                </c:pt>
                <c:pt idx="19">
                  <c:v>-17.555768394470213</c:v>
                </c:pt>
                <c:pt idx="20">
                  <c:v>-17.528481292724603</c:v>
                </c:pt>
                <c:pt idx="21">
                  <c:v>-17.142144546508785</c:v>
                </c:pt>
                <c:pt idx="22">
                  <c:v>-17.020847244262693</c:v>
                </c:pt>
                <c:pt idx="23">
                  <c:v>-16.598681678771968</c:v>
                </c:pt>
                <c:pt idx="24">
                  <c:v>-16.744514045715327</c:v>
                </c:pt>
                <c:pt idx="25">
                  <c:v>-16.893935089111327</c:v>
                </c:pt>
                <c:pt idx="26">
                  <c:v>-17.024605560302732</c:v>
                </c:pt>
                <c:pt idx="27">
                  <c:v>-17.14557296752929</c:v>
                </c:pt>
                <c:pt idx="28">
                  <c:v>-16.521041412353515</c:v>
                </c:pt>
                <c:pt idx="29">
                  <c:v>-16.593908767700199</c:v>
                </c:pt>
                <c:pt idx="30">
                  <c:v>-15.84030517578125</c:v>
                </c:pt>
              </c:numCache>
            </c:numRef>
          </c:yVal>
          <c:smooth val="1"/>
        </c:ser>
        <c:dLbls/>
        <c:axId val="91783936"/>
        <c:axId val="91785856"/>
      </c:scatterChart>
      <c:valAx>
        <c:axId val="91783936"/>
        <c:scaling>
          <c:orientation val="minMax"/>
          <c:max val="3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Days</a:t>
                </a:r>
              </a:p>
            </c:rich>
          </c:tx>
          <c:layout/>
        </c:title>
        <c:numFmt formatCode="General" sourceLinked="1"/>
        <c:majorTickMark val="none"/>
        <c:tickLblPos val="nextTo"/>
        <c:crossAx val="91785856"/>
        <c:crossesAt val="-20"/>
        <c:crossBetween val="midCat"/>
      </c:valAx>
      <c:valAx>
        <c:axId val="91785856"/>
        <c:scaling>
          <c:orientation val="minMax"/>
        </c:scaling>
        <c:axPos val="l"/>
        <c:majorGridlines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800">
                    <a:latin typeface="Arial" pitchFamily="34" charset="0"/>
                    <a:cs typeface="Arial" pitchFamily="34" charset="0"/>
                  </a:rPr>
                  <a:t>(Ct</a:t>
                </a:r>
                <a:r>
                  <a:rPr lang="es-ES" sz="800" baseline="-25000">
                    <a:latin typeface="Arial" pitchFamily="34" charset="0"/>
                    <a:cs typeface="Arial" pitchFamily="34" charset="0"/>
                  </a:rPr>
                  <a:t>gene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-Ct</a:t>
                </a:r>
                <a:r>
                  <a:rPr lang="en-US" sz="800" b="1" i="0" u="none" strike="noStrike" baseline="-25000">
                    <a:latin typeface="Arial" pitchFamily="34" charset="0"/>
                    <a:cs typeface="Arial" pitchFamily="34" charset="0"/>
                  </a:rPr>
                  <a:t>18S rRNA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)T</a:t>
                </a:r>
                <a:r>
                  <a:rPr lang="es-ES" sz="800" baseline="-25000">
                    <a:latin typeface="Arial" pitchFamily="34" charset="0"/>
                    <a:cs typeface="Arial" pitchFamily="34" charset="0"/>
                  </a:rPr>
                  <a:t>x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(Ct</a:t>
                </a:r>
                <a:r>
                  <a:rPr lang="es-ES" sz="800" b="1" i="0" baseline="-25000">
                    <a:latin typeface="Arial" pitchFamily="34" charset="0"/>
                    <a:cs typeface="Arial" pitchFamily="34" charset="0"/>
                  </a:rPr>
                  <a:t>gene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-Ct</a:t>
                </a:r>
                <a:r>
                  <a:rPr lang="en-US" sz="1000" b="1" i="0" u="none" strike="noStrike" baseline="-25000"/>
                  <a:t>18S rRNA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)T</a:t>
                </a:r>
                <a:r>
                  <a:rPr lang="es-ES" sz="800" b="1" i="0" baseline="-25000">
                    <a:latin typeface="Arial" pitchFamily="34" charset="0"/>
                    <a:cs typeface="Arial" pitchFamily="34" charset="0"/>
                  </a:rPr>
                  <a:t>0</a:t>
                </a:r>
              </a:p>
            </c:rich>
          </c:tx>
          <c:layout/>
        </c:title>
        <c:numFmt formatCode="General" sourceLinked="1"/>
        <c:majorTickMark val="none"/>
        <c:tickLblPos val="nextTo"/>
        <c:crossAx val="91783936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title>
      <c:tx>
        <c:rich>
          <a:bodyPr/>
          <a:lstStyle/>
          <a:p>
            <a:pPr>
              <a:defRPr/>
            </a:pPr>
            <a:r>
              <a:rPr lang="es-ES"/>
              <a:t>Mature</a:t>
            </a:r>
            <a:r>
              <a:rPr lang="es-ES" baseline="0"/>
              <a:t> stages</a:t>
            </a:r>
            <a:endParaRPr lang="es-ES"/>
          </a:p>
        </c:rich>
      </c:tx>
      <c:layout/>
    </c:title>
    <c:plotArea>
      <c:layout/>
      <c:scatterChart>
        <c:scatterStyle val="smoothMarker"/>
        <c:ser>
          <c:idx val="0"/>
          <c:order val="0"/>
          <c:tx>
            <c:strRef>
              <c:f>'Grafica cinetica'!$B$1</c:f>
              <c:strCache>
                <c:ptCount val="1"/>
                <c:pt idx="0">
                  <c:v>18S rRNA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B$2:$B$32</c:f>
              <c:numCache>
                <c:formatCode>General</c:formatCode>
                <c:ptCount val="3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Grafica cinetica'!$C$1</c:f>
              <c:strCache>
                <c:ptCount val="1"/>
                <c:pt idx="0">
                  <c:v>Pfs25</c:v>
                </c:pt>
              </c:strCache>
            </c:strRef>
          </c:tx>
          <c:marker>
            <c:symbol val="star"/>
            <c:size val="7"/>
            <c:spPr>
              <a:noFill/>
            </c:spPr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C$2:$C$32</c:f>
              <c:numCache>
                <c:formatCode>General</c:formatCode>
                <c:ptCount val="31"/>
                <c:pt idx="0">
                  <c:v>0</c:v>
                </c:pt>
                <c:pt idx="1">
                  <c:v>0.23904991149902347</c:v>
                </c:pt>
                <c:pt idx="2">
                  <c:v>-0.52599525451660012</c:v>
                </c:pt>
                <c:pt idx="3">
                  <c:v>-1.1837129592895501</c:v>
                </c:pt>
                <c:pt idx="4">
                  <c:v>-1.3921546936035158</c:v>
                </c:pt>
                <c:pt idx="5">
                  <c:v>-1.9139804840087893</c:v>
                </c:pt>
                <c:pt idx="6">
                  <c:v>-3.3572769165039063</c:v>
                </c:pt>
                <c:pt idx="7">
                  <c:v>-3.154510498046875</c:v>
                </c:pt>
                <c:pt idx="8">
                  <c:v>-4.6332826614379874</c:v>
                </c:pt>
                <c:pt idx="9">
                  <c:v>-4.0397167205810556</c:v>
                </c:pt>
                <c:pt idx="10">
                  <c:v>-5.0592727661132812</c:v>
                </c:pt>
                <c:pt idx="11">
                  <c:v>-5.1209278106689435</c:v>
                </c:pt>
                <c:pt idx="12">
                  <c:v>-6.3316078186035165</c:v>
                </c:pt>
                <c:pt idx="13">
                  <c:v>-6.8952445983886719</c:v>
                </c:pt>
                <c:pt idx="14">
                  <c:v>-8.276277542114256</c:v>
                </c:pt>
                <c:pt idx="15">
                  <c:v>-8.138667106628418</c:v>
                </c:pt>
                <c:pt idx="16">
                  <c:v>-9.1577892303466815</c:v>
                </c:pt>
                <c:pt idx="17">
                  <c:v>-9.5674095153808612</c:v>
                </c:pt>
                <c:pt idx="18">
                  <c:v>-10.430977821350098</c:v>
                </c:pt>
                <c:pt idx="19">
                  <c:v>-10.147711753845215</c:v>
                </c:pt>
                <c:pt idx="20">
                  <c:v>-10.294942855834963</c:v>
                </c:pt>
                <c:pt idx="21">
                  <c:v>-11.452003479003908</c:v>
                </c:pt>
                <c:pt idx="22">
                  <c:v>-11.007638931274414</c:v>
                </c:pt>
                <c:pt idx="23">
                  <c:v>-10.056824684143066</c:v>
                </c:pt>
                <c:pt idx="24">
                  <c:v>-11.686844825744631</c:v>
                </c:pt>
                <c:pt idx="25">
                  <c:v>-11.70380973815918</c:v>
                </c:pt>
                <c:pt idx="26">
                  <c:v>-12.034706115722656</c:v>
                </c:pt>
                <c:pt idx="27">
                  <c:v>-11.948728561401365</c:v>
                </c:pt>
                <c:pt idx="28">
                  <c:v>-11.691267013549805</c:v>
                </c:pt>
                <c:pt idx="29">
                  <c:v>-11.921148300170897</c:v>
                </c:pt>
                <c:pt idx="30">
                  <c:v>-11.30097198486328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Grafica cinetica'!$D$1</c:f>
              <c:strCache>
                <c:ptCount val="1"/>
                <c:pt idx="0">
                  <c:v>Pfg377</c:v>
                </c:pt>
              </c:strCache>
            </c:strRef>
          </c:tx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D$2:$D$32</c:f>
              <c:numCache>
                <c:formatCode>General</c:formatCode>
                <c:ptCount val="31"/>
                <c:pt idx="0">
                  <c:v>0</c:v>
                </c:pt>
                <c:pt idx="1">
                  <c:v>1.29763984680175</c:v>
                </c:pt>
                <c:pt idx="2">
                  <c:v>1.7695713043212891</c:v>
                </c:pt>
                <c:pt idx="3">
                  <c:v>1.6851987838745117</c:v>
                </c:pt>
                <c:pt idx="4">
                  <c:v>1.0176057815551758</c:v>
                </c:pt>
                <c:pt idx="5">
                  <c:v>1.2722606658935547</c:v>
                </c:pt>
                <c:pt idx="6">
                  <c:v>0.24284934997558594</c:v>
                </c:pt>
                <c:pt idx="7">
                  <c:v>-0.47406387329101574</c:v>
                </c:pt>
                <c:pt idx="8">
                  <c:v>-0.43107032775878912</c:v>
                </c:pt>
                <c:pt idx="9">
                  <c:v>-0.96657752990722645</c:v>
                </c:pt>
                <c:pt idx="10">
                  <c:v>-2.7066726684570299</c:v>
                </c:pt>
                <c:pt idx="11">
                  <c:v>-2.5047492980957</c:v>
                </c:pt>
                <c:pt idx="12">
                  <c:v>-3.32150077819824</c:v>
                </c:pt>
                <c:pt idx="13">
                  <c:v>-3.38435935974121</c:v>
                </c:pt>
                <c:pt idx="14">
                  <c:v>-3.1853256225585902</c:v>
                </c:pt>
                <c:pt idx="15">
                  <c:v>-3.1250982284545801</c:v>
                </c:pt>
                <c:pt idx="16">
                  <c:v>-4.2026767730712802</c:v>
                </c:pt>
                <c:pt idx="17">
                  <c:v>-4.27030181884765</c:v>
                </c:pt>
                <c:pt idx="18">
                  <c:v>-4.6109247207641602</c:v>
                </c:pt>
                <c:pt idx="19">
                  <c:v>-4.5725622177123997</c:v>
                </c:pt>
                <c:pt idx="20">
                  <c:v>-4.7356834411621005</c:v>
                </c:pt>
                <c:pt idx="21">
                  <c:v>-4.805299758911131</c:v>
                </c:pt>
                <c:pt idx="22">
                  <c:v>-5.024793624877919</c:v>
                </c:pt>
                <c:pt idx="23">
                  <c:v>-5.8852243423461896</c:v>
                </c:pt>
                <c:pt idx="24">
                  <c:v>-5.8732194900512606</c:v>
                </c:pt>
                <c:pt idx="25">
                  <c:v>-5.3861427307128906</c:v>
                </c:pt>
                <c:pt idx="26">
                  <c:v>-5.9663619995117108</c:v>
                </c:pt>
                <c:pt idx="27">
                  <c:v>-5.3241424560546795</c:v>
                </c:pt>
                <c:pt idx="28">
                  <c:v>-5.721576690673821</c:v>
                </c:pt>
                <c:pt idx="29">
                  <c:v>-5.6880645751953089</c:v>
                </c:pt>
                <c:pt idx="30">
                  <c:v>-5.9595832824707005</c:v>
                </c:pt>
              </c:numCache>
            </c:numRef>
          </c:yVal>
          <c:smooth val="1"/>
        </c:ser>
        <c:ser>
          <c:idx val="9"/>
          <c:order val="3"/>
          <c:tx>
            <c:strRef>
              <c:f>'Grafica cinetica'!$E$1</c:f>
              <c:strCache>
                <c:ptCount val="1"/>
                <c:pt idx="0">
                  <c:v>Pf77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E$2:$E$32</c:f>
              <c:numCache>
                <c:formatCode>General</c:formatCode>
                <c:ptCount val="31"/>
                <c:pt idx="0">
                  <c:v>0</c:v>
                </c:pt>
                <c:pt idx="1">
                  <c:v>1.2974185943603518</c:v>
                </c:pt>
                <c:pt idx="2">
                  <c:v>1.5696496963500974</c:v>
                </c:pt>
                <c:pt idx="3">
                  <c:v>1.6322422027587893</c:v>
                </c:pt>
                <c:pt idx="4">
                  <c:v>0.50957679748535156</c:v>
                </c:pt>
                <c:pt idx="5">
                  <c:v>0.7258625030517577</c:v>
                </c:pt>
                <c:pt idx="6">
                  <c:v>0.13339805603027344</c:v>
                </c:pt>
                <c:pt idx="7">
                  <c:v>-0.22392082214355466</c:v>
                </c:pt>
                <c:pt idx="8">
                  <c:v>-0.54454517364501964</c:v>
                </c:pt>
                <c:pt idx="9">
                  <c:v>-0.59962844848632813</c:v>
                </c:pt>
                <c:pt idx="10">
                  <c:v>-1.0894317626953123</c:v>
                </c:pt>
                <c:pt idx="11">
                  <c:v>-1.4495048522949214</c:v>
                </c:pt>
                <c:pt idx="12">
                  <c:v>-1.2045345306396482</c:v>
                </c:pt>
                <c:pt idx="13">
                  <c:v>-1.9375152587890623</c:v>
                </c:pt>
                <c:pt idx="14">
                  <c:v>-2.0554752349853511</c:v>
                </c:pt>
                <c:pt idx="15">
                  <c:v>-2.0748281478881831</c:v>
                </c:pt>
                <c:pt idx="16">
                  <c:v>-3.1847114562988281</c:v>
                </c:pt>
                <c:pt idx="17">
                  <c:v>-3.6209831237792969</c:v>
                </c:pt>
                <c:pt idx="18">
                  <c:v>-4.2508935928344735</c:v>
                </c:pt>
                <c:pt idx="19">
                  <c:v>-4.1609277725219718</c:v>
                </c:pt>
                <c:pt idx="20">
                  <c:v>-4.9348144531249991</c:v>
                </c:pt>
                <c:pt idx="21">
                  <c:v>-4.7128582000732413</c:v>
                </c:pt>
                <c:pt idx="22">
                  <c:v>-4.5903530120849618</c:v>
                </c:pt>
                <c:pt idx="23">
                  <c:v>-5.4716024398803729</c:v>
                </c:pt>
                <c:pt idx="24">
                  <c:v>-5.8664979934692383</c:v>
                </c:pt>
                <c:pt idx="25">
                  <c:v>-5.478778839111329</c:v>
                </c:pt>
                <c:pt idx="26">
                  <c:v>-5.2055816650390625</c:v>
                </c:pt>
                <c:pt idx="27">
                  <c:v>-4.8820114135742188</c:v>
                </c:pt>
                <c:pt idx="28">
                  <c:v>-4.8621559143066397</c:v>
                </c:pt>
                <c:pt idx="29">
                  <c:v>-5.5470714569091797</c:v>
                </c:pt>
                <c:pt idx="30">
                  <c:v>-5.0684261322021484</c:v>
                </c:pt>
              </c:numCache>
            </c:numRef>
          </c:yVal>
          <c:smooth val="1"/>
        </c:ser>
        <c:ser>
          <c:idx val="11"/>
          <c:order val="4"/>
          <c:tx>
            <c:strRef>
              <c:f>'Grafica cinetica'!$F$1</c:f>
              <c:strCache>
                <c:ptCount val="1"/>
                <c:pt idx="0">
                  <c:v>pfcht1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F$2:$F$32</c:f>
              <c:numCache>
                <c:formatCode>General</c:formatCode>
                <c:ptCount val="31"/>
                <c:pt idx="0">
                  <c:v>0</c:v>
                </c:pt>
                <c:pt idx="1">
                  <c:v>2.9582576751708896</c:v>
                </c:pt>
                <c:pt idx="2">
                  <c:v>2.9903278350830003</c:v>
                </c:pt>
                <c:pt idx="3">
                  <c:v>3.2414855957031197</c:v>
                </c:pt>
                <c:pt idx="4">
                  <c:v>0.90244102478027344</c:v>
                </c:pt>
                <c:pt idx="5">
                  <c:v>-0.77911281585693359</c:v>
                </c:pt>
                <c:pt idx="6">
                  <c:v>-0.78973388671875</c:v>
                </c:pt>
                <c:pt idx="7">
                  <c:v>-8.9904785156250028E-2</c:v>
                </c:pt>
                <c:pt idx="8">
                  <c:v>-2.239436149597168</c:v>
                </c:pt>
                <c:pt idx="9">
                  <c:v>-1.4659633636474605</c:v>
                </c:pt>
                <c:pt idx="10">
                  <c:v>-2.1961212158203134</c:v>
                </c:pt>
                <c:pt idx="11">
                  <c:v>-2.754486083984375</c:v>
                </c:pt>
                <c:pt idx="12">
                  <c:v>-3.6778583526611333</c:v>
                </c:pt>
                <c:pt idx="13">
                  <c:v>-2.4430084228515625</c:v>
                </c:pt>
                <c:pt idx="14">
                  <c:v>-2.5936889648437496</c:v>
                </c:pt>
                <c:pt idx="15">
                  <c:v>-2.4685564041137686</c:v>
                </c:pt>
                <c:pt idx="16">
                  <c:v>-2.7333412170410161</c:v>
                </c:pt>
                <c:pt idx="17">
                  <c:v>-1.4957370758056638</c:v>
                </c:pt>
                <c:pt idx="18">
                  <c:v>-1.4046716690063477</c:v>
                </c:pt>
                <c:pt idx="19">
                  <c:v>-0.78830242156982422</c:v>
                </c:pt>
                <c:pt idx="20">
                  <c:v>-1.0393257141113279</c:v>
                </c:pt>
                <c:pt idx="21">
                  <c:v>-1.2262992858886717</c:v>
                </c:pt>
                <c:pt idx="22">
                  <c:v>0.61606597900390625</c:v>
                </c:pt>
                <c:pt idx="23">
                  <c:v>-0.87162685394287132</c:v>
                </c:pt>
                <c:pt idx="24">
                  <c:v>-0.64615345001220703</c:v>
                </c:pt>
                <c:pt idx="25">
                  <c:v>-1.0112075805664062</c:v>
                </c:pt>
                <c:pt idx="26">
                  <c:v>0.12879943847656256</c:v>
                </c:pt>
                <c:pt idx="27">
                  <c:v>-1.1001243591308498</c:v>
                </c:pt>
                <c:pt idx="28">
                  <c:v>-0.7177085876464846</c:v>
                </c:pt>
                <c:pt idx="29">
                  <c:v>-1.2544689178466699</c:v>
                </c:pt>
                <c:pt idx="30">
                  <c:v>-1.0871467590332031</c:v>
                </c:pt>
              </c:numCache>
            </c:numRef>
          </c:yVal>
          <c:smooth val="1"/>
        </c:ser>
        <c:ser>
          <c:idx val="12"/>
          <c:order val="5"/>
          <c:tx>
            <c:strRef>
              <c:f>'Grafica cinetica'!$G$1</c:f>
              <c:strCache>
                <c:ptCount val="1"/>
                <c:pt idx="0">
                  <c:v>ROM3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G$2:$G$32</c:f>
              <c:numCache>
                <c:formatCode>General</c:formatCode>
                <c:ptCount val="31"/>
                <c:pt idx="0">
                  <c:v>0</c:v>
                </c:pt>
                <c:pt idx="1">
                  <c:v>2.4930219650268555</c:v>
                </c:pt>
                <c:pt idx="2">
                  <c:v>2.8608684539794917</c:v>
                </c:pt>
                <c:pt idx="3">
                  <c:v>2.4898433685302734</c:v>
                </c:pt>
                <c:pt idx="4">
                  <c:v>1.8691558837890625</c:v>
                </c:pt>
                <c:pt idx="5">
                  <c:v>1.4406023025512695</c:v>
                </c:pt>
                <c:pt idx="6">
                  <c:v>1.4611396789550777</c:v>
                </c:pt>
                <c:pt idx="7">
                  <c:v>1.3943490982055664</c:v>
                </c:pt>
                <c:pt idx="8">
                  <c:v>1.298149108886719</c:v>
                </c:pt>
                <c:pt idx="9">
                  <c:v>1.3931808471679685</c:v>
                </c:pt>
                <c:pt idx="10">
                  <c:v>1.2086763381958008</c:v>
                </c:pt>
                <c:pt idx="11">
                  <c:v>0.16306304931640628</c:v>
                </c:pt>
                <c:pt idx="12">
                  <c:v>-1.7488479614257819E-2</c:v>
                </c:pt>
                <c:pt idx="13">
                  <c:v>-0.51701545715332042</c:v>
                </c:pt>
                <c:pt idx="14">
                  <c:v>-0.6918907165527346</c:v>
                </c:pt>
                <c:pt idx="15">
                  <c:v>-1.9206113815307619</c:v>
                </c:pt>
                <c:pt idx="16">
                  <c:v>-2.2963409423828129</c:v>
                </c:pt>
                <c:pt idx="17">
                  <c:v>-2.0970478057861333</c:v>
                </c:pt>
                <c:pt idx="18">
                  <c:v>-2.1016159057617187</c:v>
                </c:pt>
                <c:pt idx="19">
                  <c:v>-2.0621204376220708</c:v>
                </c:pt>
                <c:pt idx="20">
                  <c:v>-3.0880470275878906</c:v>
                </c:pt>
                <c:pt idx="21">
                  <c:v>-2.4817342758178715</c:v>
                </c:pt>
                <c:pt idx="22">
                  <c:v>-3.7870788574218754</c:v>
                </c:pt>
                <c:pt idx="23">
                  <c:v>-3.9767293930053706</c:v>
                </c:pt>
                <c:pt idx="24">
                  <c:v>-4.1800823211669904</c:v>
                </c:pt>
                <c:pt idx="25">
                  <c:v>-3.9598093032836905</c:v>
                </c:pt>
                <c:pt idx="26">
                  <c:v>-3.0529651641845699</c:v>
                </c:pt>
                <c:pt idx="27">
                  <c:v>-3.7438983917236301</c:v>
                </c:pt>
                <c:pt idx="28">
                  <c:v>-3.1005887985229408</c:v>
                </c:pt>
                <c:pt idx="29">
                  <c:v>-3.1606903076171804</c:v>
                </c:pt>
                <c:pt idx="30">
                  <c:v>-3.6720867156982395</c:v>
                </c:pt>
              </c:numCache>
            </c:numRef>
          </c:yVal>
          <c:smooth val="1"/>
        </c:ser>
        <c:ser>
          <c:idx val="13"/>
          <c:order val="6"/>
          <c:tx>
            <c:strRef>
              <c:f>'Grafica cinetica'!$H$1</c:f>
              <c:strCache>
                <c:ptCount val="1"/>
                <c:pt idx="0">
                  <c:v>Pfs28</c:v>
                </c:pt>
              </c:strCache>
            </c:strRef>
          </c:tx>
          <c:marker>
            <c:symbol val="none"/>
          </c:marker>
          <c:xVal>
            <c:numRef>
              <c:f>'Grafica cinetica'!$A$2:$A$32</c:f>
              <c:numCache>
                <c:formatCode>General</c:formatCode>
                <c:ptCount val="3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</c:numCache>
            </c:numRef>
          </c:xVal>
          <c:yVal>
            <c:numRef>
              <c:f>'Grafica cinetica'!$H$2:$H$32</c:f>
              <c:numCache>
                <c:formatCode>General</c:formatCode>
                <c:ptCount val="31"/>
                <c:pt idx="0">
                  <c:v>0</c:v>
                </c:pt>
                <c:pt idx="1">
                  <c:v>0.32274436950683599</c:v>
                </c:pt>
                <c:pt idx="2">
                  <c:v>2.6350193023681636</c:v>
                </c:pt>
                <c:pt idx="3">
                  <c:v>2.2859201431274405</c:v>
                </c:pt>
                <c:pt idx="4">
                  <c:v>-0.56637786865234996</c:v>
                </c:pt>
                <c:pt idx="5">
                  <c:v>-1.4744190216064401</c:v>
                </c:pt>
                <c:pt idx="6">
                  <c:v>-2.3489379119873104</c:v>
                </c:pt>
                <c:pt idx="7">
                  <c:v>-3.6177801513672003</c:v>
                </c:pt>
                <c:pt idx="8">
                  <c:v>-5.1308170700073195</c:v>
                </c:pt>
                <c:pt idx="9">
                  <c:v>-7.6945241546629992</c:v>
                </c:pt>
                <c:pt idx="10">
                  <c:v>-10.1985922241211</c:v>
                </c:pt>
                <c:pt idx="11">
                  <c:v>-10.061564712524417</c:v>
                </c:pt>
                <c:pt idx="12">
                  <c:v>-11.149465179443363</c:v>
                </c:pt>
                <c:pt idx="13">
                  <c:v>-10.979135589599611</c:v>
                </c:pt>
                <c:pt idx="14">
                  <c:v>-11.368120727539061</c:v>
                </c:pt>
                <c:pt idx="15">
                  <c:v>-10.871415367126469</c:v>
                </c:pt>
                <c:pt idx="16">
                  <c:v>-11.701098709106445</c:v>
                </c:pt>
                <c:pt idx="17">
                  <c:v>-12.961453857421875</c:v>
                </c:pt>
                <c:pt idx="18">
                  <c:v>-13.464421882629397</c:v>
                </c:pt>
                <c:pt idx="19">
                  <c:v>-13.180768394470213</c:v>
                </c:pt>
                <c:pt idx="20">
                  <c:v>-13.913481292724612</c:v>
                </c:pt>
                <c:pt idx="21">
                  <c:v>-13.272144546508795</c:v>
                </c:pt>
                <c:pt idx="22">
                  <c:v>-12.680847244262695</c:v>
                </c:pt>
                <c:pt idx="23">
                  <c:v>-13.808681678771972</c:v>
                </c:pt>
                <c:pt idx="24">
                  <c:v>-12.489514045715334</c:v>
                </c:pt>
                <c:pt idx="25">
                  <c:v>-13.87893508911133</c:v>
                </c:pt>
                <c:pt idx="26">
                  <c:v>-13.669605560302736</c:v>
                </c:pt>
                <c:pt idx="27">
                  <c:v>-13.050572967529302</c:v>
                </c:pt>
                <c:pt idx="28">
                  <c:v>-12.966041412353515</c:v>
                </c:pt>
                <c:pt idx="29">
                  <c:v>-13.053908767700193</c:v>
                </c:pt>
                <c:pt idx="30">
                  <c:v>-12.50030517578125</c:v>
                </c:pt>
              </c:numCache>
            </c:numRef>
          </c:yVal>
          <c:smooth val="1"/>
        </c:ser>
        <c:dLbls/>
        <c:axId val="92014848"/>
        <c:axId val="92029312"/>
      </c:scatterChart>
      <c:valAx>
        <c:axId val="92014848"/>
        <c:scaling>
          <c:orientation val="minMax"/>
          <c:max val="3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Days</a:t>
                </a:r>
              </a:p>
            </c:rich>
          </c:tx>
          <c:layout/>
        </c:title>
        <c:numFmt formatCode="General" sourceLinked="1"/>
        <c:majorTickMark val="none"/>
        <c:tickLblPos val="nextTo"/>
        <c:crossAx val="92029312"/>
        <c:crossesAt val="-20"/>
        <c:crossBetween val="midCat"/>
      </c:valAx>
      <c:valAx>
        <c:axId val="92029312"/>
        <c:scaling>
          <c:orientation val="minMax"/>
          <c:max val="5"/>
          <c:min val="-20"/>
        </c:scaling>
        <c:axPos val="l"/>
        <c:majorGridlines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800">
                    <a:latin typeface="Arial" pitchFamily="34" charset="0"/>
                    <a:cs typeface="Arial" pitchFamily="34" charset="0"/>
                  </a:rPr>
                  <a:t>(Ct</a:t>
                </a:r>
                <a:r>
                  <a:rPr lang="es-ES" sz="800" baseline="-25000">
                    <a:latin typeface="Arial" pitchFamily="34" charset="0"/>
                    <a:cs typeface="Arial" pitchFamily="34" charset="0"/>
                  </a:rPr>
                  <a:t>gene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-Ct</a:t>
                </a:r>
                <a:r>
                  <a:rPr lang="en-US" sz="800" b="1" i="0" u="none" strike="noStrike" baseline="-25000">
                    <a:latin typeface="Arial" pitchFamily="34" charset="0"/>
                    <a:cs typeface="Arial" pitchFamily="34" charset="0"/>
                  </a:rPr>
                  <a:t>18S rRNA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)T</a:t>
                </a:r>
                <a:r>
                  <a:rPr lang="es-ES" sz="800" baseline="-25000">
                    <a:latin typeface="Arial" pitchFamily="34" charset="0"/>
                    <a:cs typeface="Arial" pitchFamily="34" charset="0"/>
                  </a:rPr>
                  <a:t>x</a:t>
                </a:r>
                <a:r>
                  <a:rPr lang="es-ES" sz="80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(Ct</a:t>
                </a:r>
                <a:r>
                  <a:rPr lang="es-ES" sz="800" b="1" i="0" baseline="-25000">
                    <a:latin typeface="Arial" pitchFamily="34" charset="0"/>
                    <a:cs typeface="Arial" pitchFamily="34" charset="0"/>
                  </a:rPr>
                  <a:t>gene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-Ct</a:t>
                </a:r>
                <a:r>
                  <a:rPr lang="en-US" sz="1000" b="1" i="0" u="none" strike="noStrike" baseline="-25000"/>
                  <a:t>18S rRNA</a:t>
                </a:r>
                <a:r>
                  <a:rPr lang="es-ES" sz="800" b="1" i="0" baseline="0">
                    <a:latin typeface="Arial" pitchFamily="34" charset="0"/>
                    <a:cs typeface="Arial" pitchFamily="34" charset="0"/>
                  </a:rPr>
                  <a:t>)T</a:t>
                </a:r>
                <a:r>
                  <a:rPr lang="es-ES" sz="800" b="1" i="0" baseline="-25000">
                    <a:latin typeface="Arial" pitchFamily="34" charset="0"/>
                    <a:cs typeface="Arial" pitchFamily="34" charset="0"/>
                  </a:rPr>
                  <a:t>0</a:t>
                </a:r>
              </a:p>
            </c:rich>
          </c:tx>
          <c:layout/>
        </c:title>
        <c:numFmt formatCode="General" sourceLinked="1"/>
        <c:majorTickMark val="none"/>
        <c:tickLblPos val="nextTo"/>
        <c:crossAx val="92014848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3712CB-DA9E-45C0-BBED-3ED73D14B573}" type="datetimeFigureOut">
              <a:rPr lang="en-GB" smtClean="0"/>
              <a:pPr/>
              <a:t>15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3F5D4-609E-48C1-A226-C764161B45F1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2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255948584"/>
              </p:ext>
            </p:extLst>
          </p:nvPr>
        </p:nvGraphicFramePr>
        <p:xfrm>
          <a:off x="976469" y="920552"/>
          <a:ext cx="4864799" cy="30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2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110817805"/>
              </p:ext>
            </p:extLst>
          </p:nvPr>
        </p:nvGraphicFramePr>
        <p:xfrm>
          <a:off x="976469" y="4376936"/>
          <a:ext cx="4864799" cy="30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6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laxoSmithKlin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br46295</dc:creator>
  <cp:lastModifiedBy>nbr46295</cp:lastModifiedBy>
  <cp:revision>5</cp:revision>
  <dcterms:created xsi:type="dcterms:W3CDTF">2016-03-07T17:14:43Z</dcterms:created>
  <dcterms:modified xsi:type="dcterms:W3CDTF">2016-06-15T15:43:27Z</dcterms:modified>
</cp:coreProperties>
</file>